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.tif" ContentType="image/tiff"/>
  <Override PartName="/ppt/media/image2.tif" ContentType="image/tiff"/>
  <Override PartName="/ppt/media/image3.tif" ContentType="image/tiff"/>
  <Override PartName="/ppt/media/image4.tif" ContentType="image/tiff"/>
  <Override PartName="/ppt/media/image5.tif" ContentType="image/tiff"/>
  <Override PartName="/ppt/media/image6.tif" ContentType="image/tiff"/>
  <Override PartName="/ppt/media/image7.tif" ContentType="image/tif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3808F-CEB7-4D2B-AF2E-9426C11753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35E532-68C4-4424-9788-7A72016F56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9098CA-5B32-4AA8-9958-CE7CDA9BC5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B81F7-1771-4CC6-98E4-C4D8215C34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FF35494-9AE7-458D-B800-3AAFE5C217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96FB140-1EFB-4100-BD6B-874FFB74C0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12A5948-D6AD-49DE-B82B-D198CD8028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3EB5854-6090-4DF1-8188-D8FCCB53DF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ECFDDBD-4F52-4B48-9567-60F86FB084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549752C-D6E4-422F-A3D4-3705FAD3F9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034F8FE-7885-464A-BA92-4E7A021853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7DC4A-2100-458D-A322-55FB5F4C88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288C21A-7848-4186-A180-C37E43CD18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DE76943-338F-4340-B4B2-EE81041EA9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27F387F-6128-4F70-AAA7-442509EE6A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926A4D1-B4EA-48CA-B65D-F5459B6A07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0CE238A-FD8A-4455-8D9B-5E25C79C31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B2E82-A3F5-4872-A4A8-5DE637589E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95582-FF7A-4658-B956-4495FE6661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300DB-23D1-4024-9D86-6F2C659B0B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0A995D-DDF1-4A30-9BA8-B27CDC1B8C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B83B4-8E24-43F4-9179-3F48E5D33D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AB045-9CFC-4317-8F4E-7423C701AF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C0A25-DCBF-4664-9F08-643A3018C0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0A701A-FCC6-4C2A-8F8B-CA6622B49855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ABE7B0-1C19-4534-9D8E-C96BC3AC879D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tif"/><Relationship Id="rId2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tif"/><Relationship Id="rId2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tif"/><Relationship Id="rId2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tif"/><Relationship Id="rId2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tif"/><Relationship Id="rId2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tif"/><Relationship Id="rId2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图片 1" descr="GSM3729171_P2 visualize high varible genes"/>
          <p:cNvPicPr/>
          <p:nvPr/>
        </p:nvPicPr>
        <p:blipFill>
          <a:blip r:embed="rId1"/>
          <a:stretch/>
        </p:blipFill>
        <p:spPr>
          <a:xfrm>
            <a:off x="250920" y="692280"/>
            <a:ext cx="8369280" cy="4117680"/>
          </a:xfrm>
          <a:prstGeom prst="rect">
            <a:avLst/>
          </a:prstGeom>
          <a:ln w="0">
            <a:noFill/>
          </a:ln>
        </p:spPr>
      </p:pic>
      <p:sp>
        <p:nvSpPr>
          <p:cNvPr id="83" name="文本框 2"/>
          <p:cNvSpPr/>
          <p:nvPr/>
        </p:nvSpPr>
        <p:spPr>
          <a:xfrm>
            <a:off x="1979640" y="5229360"/>
            <a:ext cx="590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GSM3729171_P2 visualize high varible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图片 3" descr="GSM3729172_P3 visualize high varible genes"/>
          <p:cNvPicPr/>
          <p:nvPr/>
        </p:nvPicPr>
        <p:blipFill>
          <a:blip r:embed="rId1"/>
          <a:stretch/>
        </p:blipFill>
        <p:spPr>
          <a:xfrm>
            <a:off x="0" y="404640"/>
            <a:ext cx="9144000" cy="4500720"/>
          </a:xfrm>
          <a:prstGeom prst="rect">
            <a:avLst/>
          </a:prstGeom>
          <a:ln w="0">
            <a:noFill/>
          </a:ln>
        </p:spPr>
      </p:pic>
      <p:sp>
        <p:nvSpPr>
          <p:cNvPr id="85" name="文本框 4"/>
          <p:cNvSpPr/>
          <p:nvPr/>
        </p:nvSpPr>
        <p:spPr>
          <a:xfrm>
            <a:off x="1547640" y="5445000"/>
            <a:ext cx="6348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GSM3729172_P3 visualize high varible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图片 1" descr="GSM3729173_P4 visualize high varible genes"/>
          <p:cNvPicPr/>
          <p:nvPr/>
        </p:nvPicPr>
        <p:blipFill>
          <a:blip r:embed="rId1"/>
          <a:stretch/>
        </p:blipFill>
        <p:spPr>
          <a:xfrm>
            <a:off x="0" y="549360"/>
            <a:ext cx="9144000" cy="4498920"/>
          </a:xfrm>
          <a:prstGeom prst="rect">
            <a:avLst/>
          </a:prstGeom>
          <a:ln w="0">
            <a:noFill/>
          </a:ln>
        </p:spPr>
      </p:pic>
      <p:sp>
        <p:nvSpPr>
          <p:cNvPr id="87" name="文本框 2"/>
          <p:cNvSpPr/>
          <p:nvPr/>
        </p:nvSpPr>
        <p:spPr>
          <a:xfrm>
            <a:off x="1979640" y="5516640"/>
            <a:ext cx="546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GSM3729173_P4 visualize high varible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图片 1" descr="GSM3729174_M1 visualize high varible genes"/>
          <p:cNvPicPr/>
          <p:nvPr/>
        </p:nvPicPr>
        <p:blipFill>
          <a:blip r:embed="rId1"/>
          <a:stretch/>
        </p:blipFill>
        <p:spPr>
          <a:xfrm>
            <a:off x="0" y="836640"/>
            <a:ext cx="9144000" cy="4489560"/>
          </a:xfrm>
          <a:prstGeom prst="rect">
            <a:avLst/>
          </a:prstGeom>
          <a:ln w="0">
            <a:noFill/>
          </a:ln>
        </p:spPr>
      </p:pic>
      <p:sp>
        <p:nvSpPr>
          <p:cNvPr id="89" name="文本框 2"/>
          <p:cNvSpPr/>
          <p:nvPr/>
        </p:nvSpPr>
        <p:spPr>
          <a:xfrm>
            <a:off x="1979640" y="5516640"/>
            <a:ext cx="638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GSM3729174_M1 visualize high varible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图片 1" descr="GSM3729175_M2 visualize high varible genes"/>
          <p:cNvPicPr/>
          <p:nvPr/>
        </p:nvPicPr>
        <p:blipFill>
          <a:blip r:embed="rId1"/>
          <a:stretch/>
        </p:blipFill>
        <p:spPr>
          <a:xfrm>
            <a:off x="34920" y="476280"/>
            <a:ext cx="9144000" cy="4479840"/>
          </a:xfrm>
          <a:prstGeom prst="rect">
            <a:avLst/>
          </a:prstGeom>
          <a:ln w="0">
            <a:noFill/>
          </a:ln>
        </p:spPr>
      </p:pic>
      <p:sp>
        <p:nvSpPr>
          <p:cNvPr id="91" name="文本框 2"/>
          <p:cNvSpPr/>
          <p:nvPr/>
        </p:nvSpPr>
        <p:spPr>
          <a:xfrm>
            <a:off x="1479600" y="5300640"/>
            <a:ext cx="5143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GSM3729175_M2 visualize high varible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图片 1" descr="GSM3729176_R1 visualize high varible genes"/>
          <p:cNvPicPr/>
          <p:nvPr/>
        </p:nvPicPr>
        <p:blipFill>
          <a:blip r:embed="rId1"/>
          <a:stretch/>
        </p:blipFill>
        <p:spPr>
          <a:xfrm>
            <a:off x="0" y="620640"/>
            <a:ext cx="9144000" cy="4500720"/>
          </a:xfrm>
          <a:prstGeom prst="rect">
            <a:avLst/>
          </a:prstGeom>
          <a:ln w="0">
            <a:noFill/>
          </a:ln>
        </p:spPr>
      </p:pic>
      <p:sp>
        <p:nvSpPr>
          <p:cNvPr id="93" name="文本框 2"/>
          <p:cNvSpPr/>
          <p:nvPr/>
        </p:nvSpPr>
        <p:spPr>
          <a:xfrm>
            <a:off x="1979640" y="5372280"/>
            <a:ext cx="5573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GSM3729176_R1 visualize high varible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图片 1" descr="GSM3729177_R2 visualize high varible genes"/>
          <p:cNvPicPr/>
          <p:nvPr/>
        </p:nvPicPr>
        <p:blipFill>
          <a:blip r:embed="rId1"/>
          <a:stretch/>
        </p:blipFill>
        <p:spPr>
          <a:xfrm>
            <a:off x="0" y="549360"/>
            <a:ext cx="9144000" cy="4498920"/>
          </a:xfrm>
          <a:prstGeom prst="rect">
            <a:avLst/>
          </a:prstGeom>
          <a:ln w="0">
            <a:noFill/>
          </a:ln>
        </p:spPr>
      </p:pic>
      <p:sp>
        <p:nvSpPr>
          <p:cNvPr id="95" name="文本框 2"/>
          <p:cNvSpPr/>
          <p:nvPr/>
        </p:nvSpPr>
        <p:spPr>
          <a:xfrm>
            <a:off x="2050920" y="5300640"/>
            <a:ext cx="558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GSM3729177_R2 visualize high varible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2-08T23:39:00Z</dcterms:created>
  <dc:creator>朱银杏</dc:creator>
  <dc:description/>
  <dc:language>en-US</dc:language>
  <cp:lastModifiedBy>朱银杏</cp:lastModifiedBy>
  <dcterms:modified xsi:type="dcterms:W3CDTF">2024-02-08T23:39:00Z</dcterms:modified>
  <cp:revision>1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D1A11E9EE1041C7A97405D41A19CA51_12</vt:lpwstr>
  </property>
  <property fmtid="{D5CDD505-2E9C-101B-9397-08002B2CF9AE}" pid="3" name="KSOProductBuildVer">
    <vt:lpwstr>2052-12.1.0.16388</vt:lpwstr>
  </property>
</Properties>
</file>